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17" d="100"/>
          <a:sy n="117" d="100"/>
        </p:scale>
        <p:origin x="164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069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3647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799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894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154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654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134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5088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9235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8880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429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FC02D-532A-6049-AC8A-350768189935}" type="datetimeFigureOut">
              <a:t>2022/1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15A8B-6C41-9443-A626-B29DC5102D34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287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32B946DF-99FC-56DF-5945-669CF167AED2}"/>
              </a:ext>
            </a:extLst>
          </p:cNvPr>
          <p:cNvGrpSpPr>
            <a:grpSpLocks noChangeAspect="1"/>
          </p:cNvGrpSpPr>
          <p:nvPr/>
        </p:nvGrpSpPr>
        <p:grpSpPr>
          <a:xfrm>
            <a:off x="1498844" y="59623"/>
            <a:ext cx="7100916" cy="6738755"/>
            <a:chOff x="1535474" y="1024358"/>
            <a:chExt cx="5986554" cy="5681233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9EBA7D3C-BA9B-D186-84D3-7640DCBB12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2886" t="11552" r="21009" b="4436"/>
            <a:stretch/>
          </p:blipFill>
          <p:spPr>
            <a:xfrm>
              <a:off x="2383971" y="1808243"/>
              <a:ext cx="5138057" cy="4897348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34691B9-8BCD-B6F2-7F3E-D368349DA529}"/>
                </a:ext>
              </a:extLst>
            </p:cNvPr>
            <p:cNvSpPr txBox="1"/>
            <p:nvPr/>
          </p:nvSpPr>
          <p:spPr>
            <a:xfrm>
              <a:off x="1535474" y="2131734"/>
              <a:ext cx="474391" cy="198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10 bp</a:t>
              </a: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C6B8E5F-301B-902E-33BE-447B472404FD}"/>
                </a:ext>
              </a:extLst>
            </p:cNvPr>
            <p:cNvSpPr txBox="1"/>
            <p:nvPr/>
          </p:nvSpPr>
          <p:spPr>
            <a:xfrm>
              <a:off x="1535474" y="2374192"/>
              <a:ext cx="474391" cy="198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9 bp</a:t>
              </a: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9A2F231-9CF7-A926-B250-C46B6DF79FDE}"/>
                </a:ext>
              </a:extLst>
            </p:cNvPr>
            <p:cNvSpPr txBox="1"/>
            <p:nvPr/>
          </p:nvSpPr>
          <p:spPr>
            <a:xfrm>
              <a:off x="1535474" y="2632026"/>
              <a:ext cx="474391" cy="198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4 bp</a:t>
              </a: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AA5E988-AE06-588E-7C00-CEA3D518004F}"/>
                </a:ext>
              </a:extLst>
            </p:cNvPr>
            <p:cNvSpPr txBox="1"/>
            <p:nvPr/>
          </p:nvSpPr>
          <p:spPr>
            <a:xfrm>
              <a:off x="1535474" y="2909024"/>
              <a:ext cx="474391" cy="198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28 bp</a:t>
              </a: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010A82C2-E174-BCDE-C17B-FAAE7FE27784}"/>
                </a:ext>
              </a:extLst>
            </p:cNvPr>
            <p:cNvSpPr txBox="1"/>
            <p:nvPr/>
          </p:nvSpPr>
          <p:spPr>
            <a:xfrm rot="16200000">
              <a:off x="2198029" y="1424194"/>
              <a:ext cx="1111044" cy="3113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Bluescript SK(+) </a:t>
              </a:r>
            </a:p>
            <a:p>
              <a:r>
                <a:rPr kumimoji="1" lang="en-US" altLang="ja-JP" sz="90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gested with Hap II</a:t>
              </a:r>
            </a:p>
          </p:txBody>
        </p: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8FB60819-AB83-10FE-EAAF-29E46DB2162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12405" y="2235925"/>
              <a:ext cx="777240" cy="457200"/>
            </a:xfrm>
            <a:prstGeom prst="line">
              <a:avLst/>
            </a:prstGeom>
            <a:ln w="190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B1F61B12-4D71-3812-1ACE-0B01E4A0E59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07325" y="2474685"/>
              <a:ext cx="787400" cy="360680"/>
            </a:xfrm>
            <a:prstGeom prst="line">
              <a:avLst/>
            </a:prstGeom>
            <a:ln w="190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7CF05A08-97EF-2F47-AD50-A95F2FF6936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07325" y="2733765"/>
              <a:ext cx="792480" cy="198120"/>
            </a:xfrm>
            <a:prstGeom prst="line">
              <a:avLst/>
            </a:prstGeom>
            <a:ln w="190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97ABC206-BBA0-C0D0-8271-548EBE3338C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02245" y="3008085"/>
              <a:ext cx="787400" cy="5080"/>
            </a:xfrm>
            <a:prstGeom prst="line">
              <a:avLst/>
            </a:prstGeom>
            <a:ln w="190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267A99EB-D91B-1618-78D1-9F5CBD8A1B45}"/>
                </a:ext>
              </a:extLst>
            </p:cNvPr>
            <p:cNvSpPr txBox="1"/>
            <p:nvPr/>
          </p:nvSpPr>
          <p:spPr>
            <a:xfrm rot="16200000">
              <a:off x="5832431" y="1424194"/>
              <a:ext cx="1111044" cy="3113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Bluescript SK(+) </a:t>
              </a:r>
            </a:p>
            <a:p>
              <a:r>
                <a:rPr kumimoji="1" lang="en-US" altLang="ja-JP" sz="90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gested with Hap II</a:t>
              </a:r>
            </a:p>
          </p:txBody>
        </p:sp>
      </p:grp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5B91BC1-9214-2FB4-7D42-B0A3B934D4BA}"/>
              </a:ext>
            </a:extLst>
          </p:cNvPr>
          <p:cNvSpPr txBox="1"/>
          <p:nvPr/>
        </p:nvSpPr>
        <p:spPr>
          <a:xfrm rot="16200000">
            <a:off x="3107446" y="409471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K195</a:t>
            </a:r>
            <a:endParaRPr lang="ja-JP" altLang="en-US" sz="900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7666719-C622-BDF5-0441-0AF4BDD73256}"/>
              </a:ext>
            </a:extLst>
          </p:cNvPr>
          <p:cNvSpPr txBox="1"/>
          <p:nvPr/>
        </p:nvSpPr>
        <p:spPr>
          <a:xfrm rot="16200000">
            <a:off x="3470645" y="403834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K291</a:t>
            </a:r>
            <a:endParaRPr lang="ja-JP" altLang="en-US" sz="900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DC48E95-FEBD-0458-D8CE-B321466FA4B4}"/>
              </a:ext>
            </a:extLst>
          </p:cNvPr>
          <p:cNvSpPr txBox="1"/>
          <p:nvPr/>
        </p:nvSpPr>
        <p:spPr>
          <a:xfrm>
            <a:off x="5353307" y="307171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2</a:t>
            </a:r>
            <a:endParaRPr lang="ja-JP" altLang="en-US" sz="900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D88CD55-376E-3F53-7615-EE77B0F34109}"/>
              </a:ext>
            </a:extLst>
          </p:cNvPr>
          <p:cNvSpPr txBox="1"/>
          <p:nvPr/>
        </p:nvSpPr>
        <p:spPr>
          <a:xfrm>
            <a:off x="5306820" y="592466"/>
            <a:ext cx="4122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RE</a:t>
            </a:r>
            <a:endParaRPr lang="ja-JP" altLang="en-US" sz="900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87C9D27-89A0-0028-D693-918193A14A10}"/>
              </a:ext>
            </a:extLst>
          </p:cNvPr>
          <p:cNvSpPr txBox="1"/>
          <p:nvPr/>
        </p:nvSpPr>
        <p:spPr>
          <a:xfrm rot="16200000">
            <a:off x="3362910" y="633535"/>
            <a:ext cx="412292" cy="7918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440"/>
              </a:lnSpc>
            </a:pPr>
            <a:r>
              <a:rPr lang="en-US" altLang="ja-JP" sz="9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RE</a:t>
            </a:r>
          </a:p>
          <a:p>
            <a:pPr>
              <a:lnSpc>
                <a:spcPts val="1440"/>
              </a:lnSpc>
            </a:pPr>
            <a:r>
              <a:rPr lang="en-US" altLang="ja-JP" sz="9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RE</a:t>
            </a:r>
            <a:endParaRPr lang="ja-JP" altLang="en-US" sz="900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440"/>
              </a:lnSpc>
            </a:pPr>
            <a:r>
              <a:rPr lang="en-US" altLang="ja-JP" sz="9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RE</a:t>
            </a:r>
          </a:p>
          <a:p>
            <a:pPr>
              <a:lnSpc>
                <a:spcPts val="1440"/>
              </a:lnSpc>
            </a:pPr>
            <a:r>
              <a:rPr lang="en-US" altLang="ja-JP" sz="900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RE</a:t>
            </a:r>
            <a:endParaRPr lang="ja-JP" altLang="en-US" sz="900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1587ADFE-AF07-A37D-5CB9-A2671BE45D5B}"/>
              </a:ext>
            </a:extLst>
          </p:cNvPr>
          <p:cNvCxnSpPr>
            <a:cxnSpLocks/>
          </p:cNvCxnSpPr>
          <p:nvPr/>
        </p:nvCxnSpPr>
        <p:spPr>
          <a:xfrm>
            <a:off x="3232110" y="816740"/>
            <a:ext cx="288000" cy="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F71FF6F6-47E0-D96C-1EF9-70B263A3B690}"/>
              </a:ext>
            </a:extLst>
          </p:cNvPr>
          <p:cNvCxnSpPr>
            <a:cxnSpLocks/>
          </p:cNvCxnSpPr>
          <p:nvPr/>
        </p:nvCxnSpPr>
        <p:spPr>
          <a:xfrm>
            <a:off x="3964966" y="823298"/>
            <a:ext cx="3096000" cy="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5D899D03-4E49-E1EB-4DDC-88AAE319E37A}"/>
              </a:ext>
            </a:extLst>
          </p:cNvPr>
          <p:cNvCxnSpPr>
            <a:cxnSpLocks/>
          </p:cNvCxnSpPr>
          <p:nvPr/>
        </p:nvCxnSpPr>
        <p:spPr>
          <a:xfrm>
            <a:off x="3569056" y="816740"/>
            <a:ext cx="288000" cy="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25950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35</Words>
  <Application>Microsoft Macintosh PowerPoint</Application>
  <PresentationFormat>A4 210 x 297 mm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久保 友彦</dc:creator>
  <cp:lastModifiedBy>久保 友彦</cp:lastModifiedBy>
  <cp:revision>12</cp:revision>
  <dcterms:created xsi:type="dcterms:W3CDTF">2022-11-14T05:39:50Z</dcterms:created>
  <dcterms:modified xsi:type="dcterms:W3CDTF">2022-11-16T06:49:55Z</dcterms:modified>
</cp:coreProperties>
</file>